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26C7CC-6B25-ED75-E627-DE8331BB8F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D14043-95D1-7A77-9E8E-210E263276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06ACB5-E064-990E-D3BB-9E3857725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02C9E7-04EE-BA85-4E68-3DA0CF4D3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6307B6-9AD1-7B03-04D3-804611306D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695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B8EE3D-6B3E-DCA7-B7CC-AE2D52741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DDAEAC-CD87-A5E5-A99F-E5A5EC727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3976EF-8E39-8543-072A-4A9413523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5821FF-5875-45FE-7C5C-014C20931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7BD495-F614-253E-2BB7-73A6BF223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828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86619A-FD43-3E7C-2F1B-BA7F81CD31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85F983-6AC8-3017-0455-58ECA21AAB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7E137B-7D3D-E499-B730-715109989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78CDE5-FF65-894B-DA99-CDDD540B7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7651E7-9F31-B103-BF14-7F852CC98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325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7065F1-FA1E-B6D7-41F9-4A04BC19C5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6E701A-1C4C-8B4A-B1F1-2B5F3F59A5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B16A34-49A0-5224-2B4B-D1E7151EA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00C345-8F85-572F-E212-CD97266C2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81FBCC-BD86-73F9-4922-19D5ACBC2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274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3E1CE4-4967-F431-2ABC-5F160D555C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15BFE9-A609-1549-91DA-5BA489BC06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94094-06C9-6917-16BF-AA969FEAC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36AA44-2B55-16B9-BC6E-83920EE5F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234CA1-00CF-2105-0C30-1996D9FAF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956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8684B-6C2E-1D56-9AD0-A3F415903F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E21B79-53E6-3E37-3A70-C4D4E9CDA7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F031D1-A7FF-D36C-7F31-AFCB7C78D4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6A52C7-F4CE-78CF-1376-2F27C5F4E8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7A98E3-E5A8-26C2-05EC-DE469E1C6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32FAA0-1426-6400-2F76-9C2FEF82E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725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A7B700-E6FE-3BE8-0629-53058D999A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ABBA6D-D95B-3EDD-D445-B1EEA03417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9CE4D7-6CA3-7B4E-8804-A5568F6461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1E4887-C89B-771C-3C62-CB48EBD84B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5E283D8-C0EE-9985-53CD-B5D3CA401B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97D703-073A-5F07-9ACA-E5BFD937F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9C4B43-BC21-EFF4-D950-FB1367F30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4614FE-E717-646C-2E4C-38DB2750A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379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2E1F8B-9D8C-177C-3344-A7444AC7A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27F256-7C99-E143-C064-642D07494C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1A1FEE6-A2ED-54FA-4A67-44CCED4DF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21A6B07-43B4-AA42-0F58-A9E698879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049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A5A6C7-E2A6-2980-DAAE-AD79F805A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6F836C-A160-3DCA-7337-A55810DBD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D9CAB6-CFBA-F493-FE9E-43CB7E0A1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860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3EB908-B022-7613-65E2-B151AE563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9D2FB0-9EAB-2A3F-3DA2-7B9A0B5EA3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4441CB-E496-5C3E-1A20-751D0E02ED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FC713E-BFF2-0BE9-BED1-ED7D19496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29D0D3-2FF4-438C-DAC7-595800917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C5CFB0-88FC-7C67-212E-2058D5BE4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811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ACE923-028B-8520-F341-6A2B4C8C66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EC45961-7DC8-D625-A8F5-05B8F439BE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268D45-2AB0-3AF0-6ECF-B767F7AD99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0B0DFD-52D4-46EE-27BC-2AFD8A7D9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E194C2-C1BD-897C-D36A-8D4B83D39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D0C923-1F6B-3043-DBE7-988E9A1C3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564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3986D4-195F-F367-1B94-CC0B981208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4FA881-48C3-FD48-A44A-044FB835BF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B4CE1-C632-690B-1E95-9F6F54A8A9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48E92F-D457-45F3-8378-3DF69EE1C351}" type="datetimeFigureOut">
              <a:rPr lang="en-US" smtClean="0"/>
              <a:t>2/1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72594A-1F0C-A341-5F1D-69907EEC96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E307C-BD7A-C83E-7962-5F19A8E835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169882-982D-4795-B52B-5097A600BC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158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5EB7973-7A51-FCA1-EB67-607900137639}"/>
              </a:ext>
            </a:extLst>
          </p:cNvPr>
          <p:cNvSpPr txBox="1"/>
          <p:nvPr/>
        </p:nvSpPr>
        <p:spPr>
          <a:xfrm>
            <a:off x="5116285" y="1986250"/>
            <a:ext cx="1240970" cy="923330"/>
          </a:xfrm>
          <a:prstGeom prst="rect">
            <a:avLst/>
          </a:prstGeom>
          <a:ln/>
          <a:scene3d>
            <a:camera prst="orthographicFront"/>
            <a:lightRig rig="threePt" dir="t"/>
          </a:scene3d>
          <a:sp3d>
            <a:bevelT/>
          </a:sp3d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heh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goon Ecosyste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4E20B90-8816-1450-AB4F-771EFE41B03F}"/>
              </a:ext>
            </a:extLst>
          </p:cNvPr>
          <p:cNvSpPr txBox="1"/>
          <p:nvPr/>
        </p:nvSpPr>
        <p:spPr>
          <a:xfrm>
            <a:off x="4273420" y="3612109"/>
            <a:ext cx="2724539" cy="369332"/>
          </a:xfrm>
          <a:prstGeom prst="rect">
            <a:avLst/>
          </a:prstGeom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3">
            <a:schemeClr val="lt1"/>
          </a:lnRef>
          <a:fillRef idx="1">
            <a:schemeClr val="accent6"/>
          </a:fillRef>
          <a:effectRef idx="1">
            <a:schemeClr val="accent6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en-US" dirty="0"/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muniti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75B9344-21AB-8C5A-7364-B4F2589F6E9C}"/>
              </a:ext>
            </a:extLst>
          </p:cNvPr>
          <p:cNvSpPr txBox="1"/>
          <p:nvPr/>
        </p:nvSpPr>
        <p:spPr>
          <a:xfrm>
            <a:off x="4716620" y="4226772"/>
            <a:ext cx="1982756" cy="307777"/>
          </a:xfrm>
          <a:prstGeom prst="rect">
            <a:avLst/>
          </a:prstGeom>
          <a:noFill/>
          <a:ln>
            <a:solidFill>
              <a:schemeClr val="accent1"/>
            </a:solidFill>
            <a:prstDash val="lgDash"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toplankton Diversity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DE685B-64B4-A76C-7D3A-8C98EFCD686C}"/>
              </a:ext>
            </a:extLst>
          </p:cNvPr>
          <p:cNvSpPr txBox="1"/>
          <p:nvPr/>
        </p:nvSpPr>
        <p:spPr>
          <a:xfrm>
            <a:off x="4730616" y="4804739"/>
            <a:ext cx="1982756" cy="307777"/>
          </a:xfrm>
          <a:prstGeom prst="rect">
            <a:avLst/>
          </a:prstGeom>
          <a:noFill/>
          <a:ln>
            <a:solidFill>
              <a:schemeClr val="accent1"/>
            </a:solidFill>
            <a:prstDash val="lgDash"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oplankton Abundan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F13A2B2-70A1-8C01-8973-DE3E8C152C84}"/>
              </a:ext>
            </a:extLst>
          </p:cNvPr>
          <p:cNvSpPr txBox="1"/>
          <p:nvPr/>
        </p:nvSpPr>
        <p:spPr>
          <a:xfrm>
            <a:off x="4744613" y="5352663"/>
            <a:ext cx="1982756" cy="307777"/>
          </a:xfrm>
          <a:prstGeom prst="rect">
            <a:avLst/>
          </a:prstGeom>
          <a:noFill/>
          <a:ln>
            <a:solidFill>
              <a:schemeClr val="accent1"/>
            </a:solidFill>
            <a:prstDash val="lgDash"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crobenthic Fauna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AEDC16C2-E4CE-08FA-6E62-2AD4F667D6AF}"/>
              </a:ext>
            </a:extLst>
          </p:cNvPr>
          <p:cNvCxnSpPr/>
          <p:nvPr/>
        </p:nvCxnSpPr>
        <p:spPr>
          <a:xfrm>
            <a:off x="4404049" y="3981441"/>
            <a:ext cx="0" cy="15329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C632189-ADE1-150F-5BC4-2D3C88E2DACB}"/>
              </a:ext>
            </a:extLst>
          </p:cNvPr>
          <p:cNvCxnSpPr>
            <a:stCxn id="9" idx="1"/>
          </p:cNvCxnSpPr>
          <p:nvPr/>
        </p:nvCxnSpPr>
        <p:spPr>
          <a:xfrm flipH="1" flipV="1">
            <a:off x="4404049" y="4376057"/>
            <a:ext cx="312571" cy="46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497B057C-3771-9524-4240-9BCEE9C0E385}"/>
              </a:ext>
            </a:extLst>
          </p:cNvPr>
          <p:cNvCxnSpPr/>
          <p:nvPr/>
        </p:nvCxnSpPr>
        <p:spPr>
          <a:xfrm flipH="1" flipV="1">
            <a:off x="4413380" y="4959957"/>
            <a:ext cx="312571" cy="46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3296D74-1E8A-85BA-B9F5-BB92955E6B91}"/>
              </a:ext>
            </a:extLst>
          </p:cNvPr>
          <p:cNvCxnSpPr/>
          <p:nvPr/>
        </p:nvCxnSpPr>
        <p:spPr>
          <a:xfrm flipH="1" flipV="1">
            <a:off x="4413380" y="5501951"/>
            <a:ext cx="312571" cy="46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Group 22">
            <a:extLst>
              <a:ext uri="{FF2B5EF4-FFF2-40B4-BE49-F238E27FC236}">
                <a16:creationId xmlns:a16="http://schemas.microsoft.com/office/drawing/2014/main" id="{C8119147-91F2-0061-1312-ABBC434A0070}"/>
              </a:ext>
            </a:extLst>
          </p:cNvPr>
          <p:cNvGrpSpPr/>
          <p:nvPr/>
        </p:nvGrpSpPr>
        <p:grpSpPr>
          <a:xfrm>
            <a:off x="7217250" y="4549570"/>
            <a:ext cx="2379295" cy="818114"/>
            <a:chOff x="7161267" y="4103722"/>
            <a:chExt cx="2379295" cy="818114"/>
          </a:xfrm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</p:grpSpPr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388E4D65-5BE0-1361-F14A-277473473376}"/>
                </a:ext>
              </a:extLst>
            </p:cNvPr>
            <p:cNvSpPr/>
            <p:nvPr/>
          </p:nvSpPr>
          <p:spPr>
            <a:xfrm>
              <a:off x="7161267" y="4103722"/>
              <a:ext cx="2379295" cy="818114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p3d>
              <a:bevelT w="190500" h="38100"/>
            </a:sp3d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06BABDE-0EDA-DE1C-A2D2-FA2A1E6234BB}"/>
                </a:ext>
              </a:extLst>
            </p:cNvPr>
            <p:cNvSpPr txBox="1"/>
            <p:nvPr/>
          </p:nvSpPr>
          <p:spPr>
            <a:xfrm>
              <a:off x="7324548" y="4328113"/>
              <a:ext cx="2052732" cy="369332"/>
            </a:xfrm>
            <a:prstGeom prst="rect">
              <a:avLst/>
            </a:prstGeom>
            <a:noFill/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p3d>
              <a:bevelT w="190500" h="38100"/>
            </a:sp3d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sence of Artemia</a:t>
              </a:r>
            </a:p>
          </p:txBody>
        </p:sp>
      </p:grp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7AC22FDB-293C-401A-F1E1-9DCA643A9403}"/>
              </a:ext>
            </a:extLst>
          </p:cNvPr>
          <p:cNvCxnSpPr>
            <a:stCxn id="10" idx="3"/>
            <a:endCxn id="22" idx="2"/>
          </p:cNvCxnSpPr>
          <p:nvPr/>
        </p:nvCxnSpPr>
        <p:spPr>
          <a:xfrm flipV="1">
            <a:off x="6713372" y="4958627"/>
            <a:ext cx="50387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7" name="Picture 26">
            <a:extLst>
              <a:ext uri="{FF2B5EF4-FFF2-40B4-BE49-F238E27FC236}">
                <a16:creationId xmlns:a16="http://schemas.microsoft.com/office/drawing/2014/main" id="{2DB6BE52-1502-16FE-3628-A8863B1FFE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3420" y="502079"/>
            <a:ext cx="2581275" cy="904875"/>
          </a:xfrm>
          <a:prstGeom prst="round2DiagRect">
            <a:avLst>
              <a:gd name="adj1" fmla="val 16667"/>
              <a:gd name="adj2" fmla="val 0"/>
            </a:avLst>
          </a:prstGeom>
          <a:ln w="88900" cap="sq">
            <a:solidFill>
              <a:srgbClr val="FFFFFF"/>
            </a:solidFill>
            <a:miter lim="800000"/>
          </a:ln>
          <a:effectLst>
            <a:outerShdw blurRad="254000" algn="tl" rotWithShape="0">
              <a:srgbClr val="000000">
                <a:alpha val="43000"/>
              </a:srgbClr>
            </a:outerShdw>
          </a:effectLst>
        </p:spPr>
      </p:pic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ACE89C1C-5059-B875-1120-47FD24B7389F}"/>
              </a:ext>
            </a:extLst>
          </p:cNvPr>
          <p:cNvCxnSpPr>
            <a:cxnSpLocks/>
            <a:stCxn id="4" idx="2"/>
          </p:cNvCxnSpPr>
          <p:nvPr/>
        </p:nvCxnSpPr>
        <p:spPr>
          <a:xfrm flipH="1">
            <a:off x="5735991" y="2909580"/>
            <a:ext cx="779" cy="702529"/>
          </a:xfrm>
          <a:prstGeom prst="straightConnector1">
            <a:avLst/>
          </a:prstGeom>
          <a:ln w="19050">
            <a:solidFill>
              <a:schemeClr val="bg2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Hexagon 30">
            <a:extLst>
              <a:ext uri="{FF2B5EF4-FFF2-40B4-BE49-F238E27FC236}">
                <a16:creationId xmlns:a16="http://schemas.microsoft.com/office/drawing/2014/main" id="{A53F2B5C-01D6-CAA4-D699-33BE398FCD5E}"/>
              </a:ext>
            </a:extLst>
          </p:cNvPr>
          <p:cNvSpPr/>
          <p:nvPr/>
        </p:nvSpPr>
        <p:spPr>
          <a:xfrm>
            <a:off x="9134669" y="653141"/>
            <a:ext cx="2034074" cy="1076127"/>
          </a:xfrm>
          <a:prstGeom prst="hexagon">
            <a:avLst/>
          </a:prstGeom>
          <a:scene3d>
            <a:camera prst="orthographicFront"/>
            <a:lightRig rig="threePt" dir="t"/>
          </a:scene3d>
          <a:sp3d>
            <a:bevelT w="165100" prst="coolSlant"/>
          </a:sp3d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BB6C67B-F747-2BA7-E6F2-0EC61F3BEC5D}"/>
              </a:ext>
            </a:extLst>
          </p:cNvPr>
          <p:cNvSpPr txBox="1"/>
          <p:nvPr/>
        </p:nvSpPr>
        <p:spPr>
          <a:xfrm>
            <a:off x="9274629" y="905066"/>
            <a:ext cx="17541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ochemical Parameter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01CD6F0-76BA-9CB7-AE9A-F328F8999A53}"/>
              </a:ext>
            </a:extLst>
          </p:cNvPr>
          <p:cNvSpPr txBox="1"/>
          <p:nvPr/>
        </p:nvSpPr>
        <p:spPr>
          <a:xfrm>
            <a:off x="8966727" y="1838134"/>
            <a:ext cx="2276662" cy="338554"/>
          </a:xfrm>
          <a:prstGeom prst="rect">
            <a:avLst/>
          </a:prstGeom>
          <a:ln/>
        </p:spPr>
        <p:style>
          <a:lnRef idx="3">
            <a:schemeClr val="lt1"/>
          </a:lnRef>
          <a:fillRef idx="1">
            <a:schemeClr val="dk1"/>
          </a:fillRef>
          <a:effectRef idx="1">
            <a:schemeClr val="dk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Salinity Level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06F32F6-2AB3-FFA0-C1BB-308C6EEF2584}"/>
              </a:ext>
            </a:extLst>
          </p:cNvPr>
          <p:cNvSpPr txBox="1"/>
          <p:nvPr/>
        </p:nvSpPr>
        <p:spPr>
          <a:xfrm>
            <a:off x="8677469" y="2261111"/>
            <a:ext cx="2789853" cy="338554"/>
          </a:xfrm>
          <a:prstGeom prst="rect">
            <a:avLst/>
          </a:prstGeom>
          <a:ln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 pH affecting Biodiversity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F45061A-FE6E-D39B-21B7-E94F5E8F3984}"/>
              </a:ext>
            </a:extLst>
          </p:cNvPr>
          <p:cNvSpPr txBox="1"/>
          <p:nvPr/>
        </p:nvSpPr>
        <p:spPr>
          <a:xfrm>
            <a:off x="8683683" y="2721428"/>
            <a:ext cx="2789854" cy="338554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Nitrate Concentration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3216B71-DF22-FF11-25E4-443122E0AF11}"/>
              </a:ext>
            </a:extLst>
          </p:cNvPr>
          <p:cNvSpPr txBox="1"/>
          <p:nvPr/>
        </p:nvSpPr>
        <p:spPr>
          <a:xfrm>
            <a:off x="8537507" y="3125747"/>
            <a:ext cx="3106315" cy="33855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evated Calcium and Magnesium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CE56C0F-E9D4-1ACF-92B3-0AF761B0569B}"/>
              </a:ext>
            </a:extLst>
          </p:cNvPr>
          <p:cNvSpPr txBox="1"/>
          <p:nvPr/>
        </p:nvSpPr>
        <p:spPr>
          <a:xfrm>
            <a:off x="9062355" y="3567390"/>
            <a:ext cx="1922879" cy="338554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er Chemistry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AEAB655-95A8-D7B9-6ADD-E2D6006428EB}"/>
              </a:ext>
            </a:extLst>
          </p:cNvPr>
          <p:cNvSpPr txBox="1"/>
          <p:nvPr/>
        </p:nvSpPr>
        <p:spPr>
          <a:xfrm>
            <a:off x="9046797" y="4018364"/>
            <a:ext cx="1922879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trient Level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23F8B88-5F0C-AD00-0EF7-3497E410443F}"/>
              </a:ext>
            </a:extLst>
          </p:cNvPr>
          <p:cNvSpPr txBox="1"/>
          <p:nvPr/>
        </p:nvSpPr>
        <p:spPr>
          <a:xfrm>
            <a:off x="612707" y="1352745"/>
            <a:ext cx="2373086" cy="369332"/>
          </a:xfrm>
          <a:prstGeom prst="rect">
            <a:avLst/>
          </a:prstGeom>
          <a:solidFill>
            <a:srgbClr val="FFFF00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 prst="coolSlant"/>
          </a:sp3d>
        </p:spPr>
        <p:style>
          <a:lnRef idx="3">
            <a:schemeClr val="lt1"/>
          </a:lnRef>
          <a:fillRef idx="1">
            <a:schemeClr val="accent4"/>
          </a:fillRef>
          <a:effectRef idx="1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ustrial Activities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556ACD07-3A67-AD29-15D7-5B2EC81C32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1412" y="1253018"/>
            <a:ext cx="352425" cy="476250"/>
          </a:xfrm>
          <a:prstGeom prst="rect">
            <a:avLst/>
          </a:prstGeom>
          <a:ln>
            <a:noFill/>
          </a:ln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604E166C-89EF-0681-8718-B1205061B5CC}"/>
              </a:ext>
            </a:extLst>
          </p:cNvPr>
          <p:cNvSpPr txBox="1"/>
          <p:nvPr/>
        </p:nvSpPr>
        <p:spPr>
          <a:xfrm>
            <a:off x="289249" y="2090057"/>
            <a:ext cx="3452327" cy="338554"/>
          </a:xfrm>
          <a:prstGeom prst="rect">
            <a:avLst/>
          </a:prstGeom>
          <a:noFill/>
          <a:ln w="28575">
            <a:solidFill>
              <a:srgbClr val="00B0F0"/>
            </a:solidFill>
            <a:prstDash val="sys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ganese From Industrial Effluent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C518EF0-64DD-6860-14DC-BDAE30D18E38}"/>
              </a:ext>
            </a:extLst>
          </p:cNvPr>
          <p:cNvSpPr txBox="1"/>
          <p:nvPr/>
        </p:nvSpPr>
        <p:spPr>
          <a:xfrm>
            <a:off x="691245" y="2693435"/>
            <a:ext cx="2604790" cy="338554"/>
          </a:xfrm>
          <a:prstGeom prst="rect">
            <a:avLst/>
          </a:prstGeom>
          <a:noFill/>
          <a:ln w="28575">
            <a:solidFill>
              <a:srgbClr val="00B0F0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ine in Wastewater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8BF7CB7C-7054-CF2C-06B4-00C4D453127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4724" y="3330965"/>
            <a:ext cx="1833668" cy="2715272"/>
          </a:xfrm>
          <a:prstGeom prst="roundRect">
            <a:avLst>
              <a:gd name="adj" fmla="val 4167"/>
            </a:avLst>
          </a:prstGeom>
          <a:solidFill>
            <a:srgbClr val="FFFFFF"/>
          </a:solidFill>
          <a:ln w="76200" cap="sq">
            <a:solidFill>
              <a:srgbClr val="292929"/>
            </a:solidFill>
            <a:miter lim="800000"/>
          </a:ln>
          <a:effectLst>
            <a:reflection blurRad="12700" stA="28000" endPos="28000" dist="5000" dir="5400000" sy="-100000" algn="bl" rotWithShape="0"/>
          </a:effectLst>
          <a:scene3d>
            <a:camera prst="orthographicFront"/>
            <a:lightRig rig="threePt" dir="t">
              <a:rot lat="0" lon="0" rev="2700000"/>
            </a:lightRig>
          </a:scene3d>
          <a:sp3d>
            <a:bevelT h="38100"/>
            <a:contourClr>
              <a:srgbClr val="C0C0C0"/>
            </a:contourClr>
          </a:sp3d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72E68E22-F575-0CB7-0D0A-9EED5F8DC69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84859" y="4964916"/>
            <a:ext cx="1794855" cy="14358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5751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43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</dc:creator>
  <cp:lastModifiedBy>A</cp:lastModifiedBy>
  <cp:revision>3</cp:revision>
  <dcterms:created xsi:type="dcterms:W3CDTF">2024-11-13T09:06:59Z</dcterms:created>
  <dcterms:modified xsi:type="dcterms:W3CDTF">2026-02-10T10:34:54Z</dcterms:modified>
</cp:coreProperties>
</file>